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86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LISE" initials="E" lastIdx="5" clrIdx="0">
    <p:extLst>
      <p:ext uri="{19B8F6BF-5375-455C-9EA6-DF929625EA0E}">
        <p15:presenceInfo xmlns:p15="http://schemas.microsoft.com/office/powerpoint/2012/main" userId="ELIS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E0000"/>
    <a:srgbClr val="EEEAE1"/>
    <a:srgbClr val="F7F7F7"/>
    <a:srgbClr val="00FF00"/>
    <a:srgbClr val="B686E6"/>
    <a:srgbClr val="BC5D1C"/>
    <a:srgbClr val="9AC97B"/>
    <a:srgbClr val="335AA1"/>
    <a:srgbClr val="70AD47"/>
    <a:srgbClr val="997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Style clair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226" autoAdjust="0"/>
    <p:restoredTop sz="94660"/>
  </p:normalViewPr>
  <p:slideViewPr>
    <p:cSldViewPr snapToGrid="0">
      <p:cViewPr varScale="1">
        <p:scale>
          <a:sx n="79" d="100"/>
          <a:sy n="79" d="100"/>
        </p:scale>
        <p:origin x="318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418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636C90-24BC-405A-9A12-BA1DD00114A9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5D67A84-EC68-40BB-9EDF-C0B77FBEB2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72925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22010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9257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96747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2339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1482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963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17773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2232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8385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47395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61463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3181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>
            <a:extLst>
              <a:ext uri="{FF2B5EF4-FFF2-40B4-BE49-F238E27FC236}">
                <a16:creationId xmlns:a16="http://schemas.microsoft.com/office/drawing/2014/main" id="{0F0A86BF-37B5-4001-8571-AF5E5019EC0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87318289"/>
              </p:ext>
            </p:extLst>
          </p:nvPr>
        </p:nvGraphicFramePr>
        <p:xfrm>
          <a:off x="53266" y="546340"/>
          <a:ext cx="6488128" cy="2425289"/>
        </p:xfrm>
        <a:graphic>
          <a:graphicData uri="http://schemas.openxmlformats.org/drawingml/2006/table">
            <a:tbl>
              <a:tblPr/>
              <a:tblGrid>
                <a:gridCol w="107053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9428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3263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3263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1368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7548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758952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484632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64008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585216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</a:tblGrid>
              <a:tr h="712494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ditions of inoculation</a:t>
                      </a: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D0D0D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I </a:t>
                      </a:r>
                      <a:r>
                        <a:rPr lang="fr-FR" sz="1400" b="0" i="0" u="none" strike="noStrike" baseline="30000" dirty="0">
                          <a:solidFill>
                            <a:srgbClr val="0D0D0D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D0D0D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I </a:t>
                      </a:r>
                      <a:r>
                        <a:rPr lang="fr-FR" sz="1400" b="0" i="0" u="none" strike="noStrike" baseline="30000" dirty="0">
                          <a:solidFill>
                            <a:srgbClr val="0D0D0D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  <a:endParaRPr lang="fr-FR" sz="1400" b="0" i="0" u="none" strike="noStrike" dirty="0">
                        <a:solidFill>
                          <a:srgbClr val="0D0D0D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37" marR="5837" marT="583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D0D0D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SI</a:t>
                      </a:r>
                      <a:r>
                        <a:rPr lang="fr-FR" sz="1400" b="0" i="0" u="none" strike="noStrike" dirty="0">
                          <a:solidFill>
                            <a:srgbClr val="0D0D0D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fr-FR" sz="1400" b="0" i="0" u="none" strike="noStrike" baseline="30000" dirty="0">
                          <a:solidFill>
                            <a:srgbClr val="0D0D0D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endParaRPr lang="fr-FR" sz="1400" b="0" i="0" u="none" strike="noStrike" dirty="0">
                        <a:solidFill>
                          <a:srgbClr val="0D0D0D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37" marR="5837" marT="583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 err="1">
                          <a:solidFill>
                            <a:srgbClr val="0D0D0D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MSI</a:t>
                      </a:r>
                      <a:endParaRPr lang="fr-FR" sz="1100" b="0" i="0" u="none" strike="noStrike" dirty="0">
                        <a:solidFill>
                          <a:srgbClr val="0D0D0D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 err="1">
                          <a:solidFill>
                            <a:srgbClr val="0D0D0D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uMSI</a:t>
                      </a:r>
                      <a:endParaRPr lang="fr-FR" sz="1100" b="0" i="0" u="none" strike="noStrike" dirty="0">
                        <a:solidFill>
                          <a:srgbClr val="0D0D0D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37" marR="5837" marT="583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 err="1">
                          <a:solidFill>
                            <a:srgbClr val="0D0D0D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MSI</a:t>
                      </a:r>
                      <a:endParaRPr lang="fr-FR" sz="1100" b="0" i="0" u="none" strike="noStrike" dirty="0">
                        <a:solidFill>
                          <a:srgbClr val="0D0D0D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37" marR="5837" marT="583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31935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ecies</a:t>
                      </a:r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fr-FR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quantified</a:t>
                      </a:r>
                      <a:endParaRPr lang="fr-FR" sz="11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mb</a:t>
                      </a:r>
                      <a:endParaRPr 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bb</a:t>
                      </a:r>
                      <a:endParaRPr 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37" marR="5837" marT="583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bb</a:t>
                      </a:r>
                      <a:endParaRPr lang="en-US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37" marR="5837" marT="583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 err="1">
                          <a:solidFill>
                            <a:srgbClr val="0D0D0D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mb</a:t>
                      </a:r>
                      <a:endParaRPr lang="fr-FR" sz="1100" b="0" i="0" u="none" strike="noStrike" dirty="0">
                        <a:solidFill>
                          <a:srgbClr val="0D0D0D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bb</a:t>
                      </a:r>
                    </a:p>
                  </a:txBody>
                  <a:tcPr marL="5837" marR="5837" marT="583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 err="1">
                          <a:solidFill>
                            <a:srgbClr val="0D0D0D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mb</a:t>
                      </a:r>
                      <a:endParaRPr lang="fr-FR" sz="1100" b="0" i="0" u="none" strike="noStrike" dirty="0">
                        <a:solidFill>
                          <a:srgbClr val="0D0D0D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bb</a:t>
                      </a:r>
                    </a:p>
                  </a:txBody>
                  <a:tcPr marL="5837" marR="5837" marT="583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>
                          <a:solidFill>
                            <a:srgbClr val="0D0D0D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mb</a:t>
                      </a: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bb</a:t>
                      </a:r>
                    </a:p>
                  </a:txBody>
                  <a:tcPr marL="5837" marR="5837" marT="583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76172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dpi</a:t>
                      </a: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3</a:t>
                      </a: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8</a:t>
                      </a:r>
                    </a:p>
                  </a:txBody>
                  <a:tcPr marL="5837" marR="5837" marT="583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5837" marR="5837" marT="583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1</a:t>
                      </a: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5837" marR="5837" marT="583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7</a:t>
                      </a: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</a:t>
                      </a:r>
                    </a:p>
                  </a:txBody>
                  <a:tcPr marL="5837" marR="5837" marT="583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4</a:t>
                      </a: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0</a:t>
                      </a:r>
                    </a:p>
                  </a:txBody>
                  <a:tcPr marL="5837" marR="5837" marT="583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76172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 dpi</a:t>
                      </a: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23</a:t>
                      </a: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7</a:t>
                      </a:r>
                    </a:p>
                  </a:txBody>
                  <a:tcPr marL="5837" marR="5837" marT="583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7</a:t>
                      </a:r>
                    </a:p>
                  </a:txBody>
                  <a:tcPr marL="5837" marR="5837" marT="583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73</a:t>
                      </a: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3</a:t>
                      </a:r>
                    </a:p>
                  </a:txBody>
                  <a:tcPr marL="5837" marR="5837" marT="583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15</a:t>
                      </a: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6</a:t>
                      </a:r>
                    </a:p>
                  </a:txBody>
                  <a:tcPr marL="5837" marR="5837" marT="583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06</a:t>
                      </a: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8</a:t>
                      </a:r>
                    </a:p>
                  </a:txBody>
                  <a:tcPr marL="5837" marR="5837" marT="583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76172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 dpi</a:t>
                      </a: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41</a:t>
                      </a: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2</a:t>
                      </a:r>
                    </a:p>
                  </a:txBody>
                  <a:tcPr marL="5837" marR="5837" marT="583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37</a:t>
                      </a:r>
                    </a:p>
                  </a:txBody>
                  <a:tcPr marL="5837" marR="5837" marT="583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75</a:t>
                      </a: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5</a:t>
                      </a:r>
                    </a:p>
                  </a:txBody>
                  <a:tcPr marL="5837" marR="5837" marT="583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84</a:t>
                      </a: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3</a:t>
                      </a:r>
                    </a:p>
                  </a:txBody>
                  <a:tcPr marL="5837" marR="5837" marT="583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97</a:t>
                      </a: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87</a:t>
                      </a:r>
                    </a:p>
                  </a:txBody>
                  <a:tcPr marL="5837" marR="5837" marT="583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76172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 dpi</a:t>
                      </a: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5.49</a:t>
                      </a: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03</a:t>
                      </a:r>
                    </a:p>
                  </a:txBody>
                  <a:tcPr marL="5837" marR="5837" marT="583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99</a:t>
                      </a:r>
                    </a:p>
                  </a:txBody>
                  <a:tcPr marL="5837" marR="5837" marT="583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6.55</a:t>
                      </a: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97</a:t>
                      </a:r>
                    </a:p>
                  </a:txBody>
                  <a:tcPr marL="5837" marR="5837" marT="583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12 *</a:t>
                      </a: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4</a:t>
                      </a:r>
                    </a:p>
                  </a:txBody>
                  <a:tcPr marL="5837" marR="5837" marT="583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59 *</a:t>
                      </a: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75</a:t>
                      </a:r>
                    </a:p>
                  </a:txBody>
                  <a:tcPr marL="5837" marR="5837" marT="583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76172"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 dpi</a:t>
                      </a: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0.33</a:t>
                      </a: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7</a:t>
                      </a:r>
                    </a:p>
                  </a:txBody>
                  <a:tcPr marL="5837" marR="5837" marT="5837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81</a:t>
                      </a:r>
                    </a:p>
                  </a:txBody>
                  <a:tcPr marL="5837" marR="5837" marT="583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4.65</a:t>
                      </a: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62</a:t>
                      </a:r>
                    </a:p>
                  </a:txBody>
                  <a:tcPr marL="5837" marR="5837" marT="583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5.48</a:t>
                      </a: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02</a:t>
                      </a:r>
                    </a:p>
                  </a:txBody>
                  <a:tcPr marL="5837" marR="5837" marT="583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78 *</a:t>
                      </a:r>
                    </a:p>
                  </a:txBody>
                  <a:tcPr marL="5837" marR="5837" marT="5837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08</a:t>
                      </a:r>
                    </a:p>
                  </a:txBody>
                  <a:tcPr marL="5837" marR="5837" marT="5837" marB="0" anchor="ctr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</a:tbl>
          </a:graphicData>
        </a:graphic>
      </p:graphicFrame>
      <p:sp>
        <p:nvSpPr>
          <p:cNvPr id="5" name="ZoneTexte 4">
            <a:extLst>
              <a:ext uri="{FF2B5EF4-FFF2-40B4-BE49-F238E27FC236}">
                <a16:creationId xmlns:a16="http://schemas.microsoft.com/office/drawing/2014/main" id="{C7D3BE8A-94C7-8F4C-A72E-ACEB4F505552}"/>
              </a:ext>
            </a:extLst>
          </p:cNvPr>
          <p:cNvSpPr txBox="1"/>
          <p:nvPr/>
        </p:nvSpPr>
        <p:spPr>
          <a:xfrm>
            <a:off x="53266" y="0"/>
            <a:ext cx="6488128" cy="43088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6, Table S2. Biomass quantification of </a:t>
            </a:r>
            <a:r>
              <a:rPr lang="en-US" sz="11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ptosphaeria maculans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‘</a:t>
            </a:r>
            <a:r>
              <a:rPr lang="en-US" sz="11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rassicae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’ (Lmb) and </a:t>
            </a:r>
            <a:r>
              <a:rPr lang="en-US" sz="11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ptosphaeria biglobosa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‘</a:t>
            </a:r>
            <a:r>
              <a:rPr lang="en-US" sz="1100" b="1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rassicae</a:t>
            </a:r>
            <a:r>
              <a:rPr lang="en-US" sz="11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’ (Lbb) following various regimes of cotyledon infections.</a:t>
            </a:r>
            <a:endParaRPr lang="fr-FR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EDB1C728-2C19-9C4A-0B85-4BE939B16E3E}"/>
              </a:ext>
            </a:extLst>
          </p:cNvPr>
          <p:cNvSpPr txBox="1"/>
          <p:nvPr/>
        </p:nvSpPr>
        <p:spPr>
          <a:xfrm>
            <a:off x="0" y="3087082"/>
            <a:ext cx="6541394" cy="260071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400"/>
              </a:spcAft>
            </a:pP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NA (in ng) of Lmb and/or Lbb were quantified by qPCR during six kinetics of cotyledon infections:</a:t>
            </a:r>
            <a:endParaRPr lang="fr-FR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400"/>
              </a:spcAft>
            </a:pP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SI 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7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Single Species Inoculation at 10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7 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ycnidiospores.mL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1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rresponds to the control conditions.</a:t>
            </a:r>
            <a:endParaRPr lang="fr-FR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400"/>
              </a:spcAft>
            </a:pP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SI 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Single Species Inoculation at 10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 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ycnidiospores.mL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1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rresponds to the control inoculation when Lbb is inoculated at lower concentration.</a:t>
            </a:r>
            <a:endParaRPr lang="fr-FR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400"/>
              </a:spcAft>
            </a:pPr>
            <a:r>
              <a:rPr lang="en-U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MSI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: Delayed Mixed Species Inoculation. Lbb was inoculated 2 days after Lmb inoculation, both at 10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7 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ycnidiospores.mL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1 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fr-FR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400"/>
              </a:spcAft>
            </a:pPr>
            <a:r>
              <a:rPr lang="en-U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MSI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: unequal Mixed Species Inoculation. Both Lbb and Lmb were inoculated simultaneously but Lbb was inoculated at lower concentration (10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 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ycnidiospores.mL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1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</a:t>
            </a:r>
            <a:endParaRPr lang="fr-FR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400"/>
              </a:spcAft>
            </a:pPr>
            <a:r>
              <a:rPr lang="en-US" sz="11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MSI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: equal Mixed Species Inoculation. Both Lbb and Lmb were inoculated simultaneously and at the same concentration (10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7 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ycnidiospores.mL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1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</a:t>
            </a:r>
            <a:endParaRPr lang="fr-FR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spcAft>
                <a:spcPts val="400"/>
              </a:spcAft>
            </a:pP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t each time point, DNA quantities of Lmb and Lbb were compared statistically with the control condition of SSI at 10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7  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ycnidiospores.mL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1 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r Lmb and SSI at 10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7  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r 10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5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ycnidiospores.mL</a:t>
            </a:r>
            <a:r>
              <a:rPr lang="en-US" sz="11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1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or Lbb. The asterisks (*) represent a significant difference with </a:t>
            </a:r>
            <a:r>
              <a:rPr lang="en-US" sz="11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 &lt;</a:t>
            </a:r>
            <a:r>
              <a:rPr lang="en-US" sz="1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0.05.</a:t>
            </a:r>
            <a:endParaRPr lang="fr-FR" sz="11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6091677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4</TotalTime>
  <Words>305</Words>
  <Application>Microsoft Office PowerPoint</Application>
  <PresentationFormat>A4 Paper (210x297 mm)</PresentationFormat>
  <Paragraphs>7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Windows</dc:creator>
  <cp:lastModifiedBy>Graham Bell</cp:lastModifiedBy>
  <cp:revision>783</cp:revision>
  <dcterms:created xsi:type="dcterms:W3CDTF">2020-02-06T09:05:41Z</dcterms:created>
  <dcterms:modified xsi:type="dcterms:W3CDTF">2023-10-05T10:45:40Z</dcterms:modified>
</cp:coreProperties>
</file>